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31" autoAdjust="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660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AD4136-6321-834F-CD4B-A21D4B96CF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063C2BE-4720-350C-61AF-DEA90B436E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947FF3-2FFA-25FD-A5BE-970A4D8A2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83385CF-CCB5-5041-EB1C-D23C1808B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BFD4891-97BC-2AEC-9A89-7757199BB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7317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715C84-F8A0-97DD-18A7-223C553795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B3624AC-4DE1-563E-CC91-E39E71E462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368467-B0DA-6C9A-934A-3CB559513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486CF2-9705-3281-8315-77112FDF9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41F3C5B-6E4C-410A-B8AE-65C14A8C44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1450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160BBFA-2374-48CC-868C-810B8EAA3F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003A27E-4040-1800-5C9C-D2468A65DA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951D531-A100-FE05-D563-49D189717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9C0B7C0-5F36-7C6E-690F-A3085BFD3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24D74C4-E51C-D902-D78C-289009203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5253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BBA82C-0DBA-54BA-3AE4-CBC3BF2CB2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FC541FF-C6AC-2E67-11AF-E6C71062B1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E68936-A930-5572-0CA3-D1B689FEC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D4F78FF-4044-13CD-779D-463138AA8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42ABF48-01DC-6FEE-1900-3C34E4D5EE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0515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4605E3-F608-B371-8B79-2BD1BC7406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933597F-962E-D1EC-E3A8-05203E10CE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59388A-5799-A80C-A7E0-7D865DE614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8EA1D5F-8EAF-3625-AF9A-94A280D8E0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B9377DD-67D0-54C7-580D-68F5B5280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4261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075D16-0D60-2E85-70CD-0C115075BB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19A9FF9-02C1-A324-2436-830DF4171E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5DCB025-369F-21AA-EFAD-D70B4C0E96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9A75DEC-81A6-1E2E-728D-FCF6019BD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3503D6E-87BC-183B-35CF-AABAEF5FA1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C094987-DEFE-299A-DFCD-A2F332574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7073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69FFC8-C6B6-1D10-6A19-BA03A328EE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9459233-6408-6971-3975-0BCCD24576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B9DCEC2-9B7E-0F4B-6829-3E34B2F730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9AEEE6F-079F-430E-151C-3E8C59B3EE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82F4453-8A54-2A3C-BA06-61D0735304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617D7BD-D5E7-121A-179A-4192769D29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3DBE29D-2E6E-F73C-9376-B94858405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EA82D2B-E71E-52D4-A401-E3E56976A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144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2E494E-B366-D888-92CC-20E975414E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76FE998-1098-D3FD-D89D-8D14F26A9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0718832-9264-A30A-6EF4-A3455EF68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7602F80-D890-E404-7D9D-869D8CD51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6755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D1347E0-03FA-F127-8427-A95C2ECD8E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59920F4-EB6F-8576-7575-24DBC0BF7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8A5D45B-1DD8-A93E-77FA-41908630D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6213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B4F4B5-B824-00B8-F7F4-AC8ACB2D8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52BB439-8A27-214B-DBA8-1616B660AE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A192EBB-A865-CACA-438B-5698DABCC5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E1CAC09-B79E-8555-7D64-A0FE86CF8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EC20EB4-A5FA-E113-AD6A-1C7EFA28BC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8BB0551-FB5B-9D6E-E504-CA473ADD1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5789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CC5795-CF83-4EA3-3B9D-2AF593AD17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2EC1E8A-4552-1F5B-3A6A-F576A313DD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6F1E2E8-DF6F-E107-9E27-67C0E67630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B3E976B-1634-B186-BDC9-12FBECA1E8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2CDAB87-08FE-07B6-D33C-4EF758FC0A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4393C99-87E9-7D8D-E223-D5CEC4C10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808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DC81429-E905-F532-9B1E-F440C71476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629E4B3-5B87-77EB-7947-53CCEEE41B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325BAD-A5C3-29B4-5329-16D1F4A86F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CE32505-D21A-4458-B335-4F85C398E0F3}" type="datetimeFigureOut">
              <a:rPr kumimoji="1" lang="ja-JP" altLang="en-US" smtClean="0"/>
              <a:t>2026/4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B169D6B-0901-4D6D-98AE-FFA8149B94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902A98E-72F1-9294-7515-CE3B439CCE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92190E-73D7-4F12-9646-1AFCCD3B87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279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CD241E6-5D01-774E-CE6C-B61386ADA2E9}"/>
              </a:ext>
            </a:extLst>
          </p:cNvPr>
          <p:cNvSpPr txBox="1"/>
          <p:nvPr/>
        </p:nvSpPr>
        <p:spPr>
          <a:xfrm>
            <a:off x="715616" y="568547"/>
            <a:ext cx="101776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low cytometry using the LLA CD45 gating order set did not reveal any abnormal cell populations</a:t>
            </a:r>
            <a:endParaRPr kumimoji="1" lang="ja-JP" altLang="en-US" sz="2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9B2047BC-D410-EAEE-518A-A95A7C6E449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0847" t="4326" r="7690" b="54651"/>
          <a:stretch>
            <a:fillRect/>
          </a:stretch>
        </p:blipFill>
        <p:spPr>
          <a:xfrm>
            <a:off x="2620506" y="2098451"/>
            <a:ext cx="5080238" cy="4209583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7300F892-CDEC-0123-8824-FEF7C05DA82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7262" t="62581" r="8716" b="1553"/>
          <a:stretch>
            <a:fillRect/>
          </a:stretch>
        </p:blipFill>
        <p:spPr>
          <a:xfrm>
            <a:off x="7824084" y="4357946"/>
            <a:ext cx="2578874" cy="2276797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3A59511-2CCA-07DD-E02F-F6D13C488C02}"/>
              </a:ext>
            </a:extLst>
          </p:cNvPr>
          <p:cNvSpPr txBox="1"/>
          <p:nvPr/>
        </p:nvSpPr>
        <p:spPr>
          <a:xfrm>
            <a:off x="212035" y="106882"/>
            <a:ext cx="29942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Data S1</a:t>
            </a:r>
            <a:endParaRPr kumimoji="1" lang="ja-JP" altLang="en-US" sz="2400" b="1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7001D749-19BC-6109-8537-EA5C04FC4702}"/>
              </a:ext>
            </a:extLst>
          </p:cNvPr>
          <p:cNvGrpSpPr/>
          <p:nvPr/>
        </p:nvGrpSpPr>
        <p:grpSpPr>
          <a:xfrm>
            <a:off x="516836" y="2098453"/>
            <a:ext cx="2037410" cy="4063809"/>
            <a:chOff x="0" y="170517"/>
            <a:chExt cx="3352801" cy="6687483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01198637-5E08-11ED-95F5-5A0E38E785E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5351" t="4024" r="71830" b="41631"/>
            <a:stretch>
              <a:fillRect/>
            </a:stretch>
          </p:blipFill>
          <p:spPr>
            <a:xfrm>
              <a:off x="0" y="170517"/>
              <a:ext cx="3352801" cy="6687483"/>
            </a:xfrm>
            <a:prstGeom prst="rect">
              <a:avLst/>
            </a:prstGeom>
          </p:spPr>
        </p:pic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CA1D50CB-60A9-42E0-577F-9AB08379161F}"/>
                </a:ext>
              </a:extLst>
            </p:cNvPr>
            <p:cNvSpPr/>
            <p:nvPr/>
          </p:nvSpPr>
          <p:spPr>
            <a:xfrm>
              <a:off x="2681882" y="3694043"/>
              <a:ext cx="172278" cy="1457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0E9E8D99-C3A4-9EBB-C451-7CC522A5DB0C}"/>
                </a:ext>
              </a:extLst>
            </p:cNvPr>
            <p:cNvSpPr/>
            <p:nvPr/>
          </p:nvSpPr>
          <p:spPr>
            <a:xfrm>
              <a:off x="2476476" y="241851"/>
              <a:ext cx="172278" cy="145774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pic>
        <p:nvPicPr>
          <p:cNvPr id="14" name="図 13">
            <a:extLst>
              <a:ext uri="{FF2B5EF4-FFF2-40B4-BE49-F238E27FC236}">
                <a16:creationId xmlns:a16="http://schemas.microsoft.com/office/drawing/2014/main" id="{229DC734-20B0-8E32-00E6-C82CA9640EA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224" t="62581" r="43260" b="1553"/>
          <a:stretch>
            <a:fillRect/>
          </a:stretch>
        </p:blipFill>
        <p:spPr>
          <a:xfrm>
            <a:off x="7824084" y="2085196"/>
            <a:ext cx="3905892" cy="2277308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915251E-4D1E-22B4-A657-E106761ED16F}"/>
              </a:ext>
            </a:extLst>
          </p:cNvPr>
          <p:cNvSpPr txBox="1"/>
          <p:nvPr/>
        </p:nvSpPr>
        <p:spPr>
          <a:xfrm>
            <a:off x="845519" y="1676543"/>
            <a:ext cx="15001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CD45 gating)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DA6FF91-A02D-C765-50BE-5CAF209E0562}"/>
              </a:ext>
            </a:extLst>
          </p:cNvPr>
          <p:cNvSpPr txBox="1"/>
          <p:nvPr/>
        </p:nvSpPr>
        <p:spPr>
          <a:xfrm>
            <a:off x="4310964" y="1683171"/>
            <a:ext cx="15001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cell count)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947BEA4-0F79-003F-B72F-45886B162B26}"/>
              </a:ext>
            </a:extLst>
          </p:cNvPr>
          <p:cNvSpPr txBox="1"/>
          <p:nvPr/>
        </p:nvSpPr>
        <p:spPr>
          <a:xfrm>
            <a:off x="8825950" y="1676546"/>
            <a:ext cx="20540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two-color pattern)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1285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峰史 彌山</dc:creator>
  <cp:lastModifiedBy>MDPI</cp:lastModifiedBy>
  <cp:revision>2</cp:revision>
  <dcterms:created xsi:type="dcterms:W3CDTF">2026-03-12T02:10:33Z</dcterms:created>
  <dcterms:modified xsi:type="dcterms:W3CDTF">2026-04-02T03:37:58Z</dcterms:modified>
</cp:coreProperties>
</file>